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1" autoAdjust="0"/>
    <p:restoredTop sz="90306" autoAdjust="0"/>
  </p:normalViewPr>
  <p:slideViewPr>
    <p:cSldViewPr snapToGrid="0">
      <p:cViewPr>
        <p:scale>
          <a:sx n="100" d="100"/>
          <a:sy n="100" d="100"/>
        </p:scale>
        <p:origin x="1128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7F6F6B-15E1-4FAC-87DC-CD2EAA3EA086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9B0A21-7595-4CCB-9142-6D223BC8DF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098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/>
              <a:t>Supplementary Figure S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dirty="0"/>
              <a:t>Representative flow cytometry figures of high and low CD8 positive-</a:t>
            </a:r>
            <a:r>
              <a:rPr kumimoji="1" lang="en-US" altLang="ja-JP" b="0" dirty="0" err="1"/>
              <a:t>Tnaive</a:t>
            </a:r>
            <a:r>
              <a:rPr kumimoji="1" lang="en-US" altLang="ja-JP" b="0" dirty="0"/>
              <a:t>, -TCM, and –</a:t>
            </a:r>
            <a:r>
              <a:rPr kumimoji="1" lang="en-US" altLang="ja-JP" b="0" dirty="0" err="1"/>
              <a:t>Teff</a:t>
            </a:r>
            <a:r>
              <a:rPr kumimoji="1" lang="en-US" altLang="ja-JP" b="0" dirty="0"/>
              <a:t> cell groups</a:t>
            </a:r>
            <a:endParaRPr kumimoji="1" lang="ja-JP" altLang="en-US" b="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F965F0-5D48-4CB1-97B8-DB3F7F50CF6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2680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E5624CE5-7484-883F-7075-92F3F3844E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3885E316-6201-FC47-FB8B-89266B629F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066361F5-B7D7-052B-E978-5DD5E45DB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D556192-EE5F-DD99-1130-A898EC439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18AF457D-2AF0-4B8E-0629-1ACC835F9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760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9393275E-AF15-31BD-8069-981852451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FB047CC6-F818-B1BA-C92A-5763CC4F26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D97E690B-5950-2AA8-FA93-334AC9521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F2482E98-2133-275E-228B-8F97FB870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515110E2-0FD2-C446-28E2-765833521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803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FEDCA386-760C-4865-1594-1632A714EE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D511F6B6-6EEF-91DD-A5C5-2D6F67FBA9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C6244F79-228C-2BD3-395D-BBF3AC5C5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C6C6AF4A-1AA7-84E7-5182-D71ADE5D9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46004F0E-014B-B355-3B47-807D55DD8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593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299500A1-24AE-353C-C312-94A7DDC7D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2DB5D2A2-F066-00C8-DC37-08E441C9C5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525CAC08-CBF5-40A2-0B71-D45CDCF61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D7135629-C8F6-C7E6-3395-7B874C6F9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4E24F7BF-757E-3DD6-FFA1-FAAEC9FD6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173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4681162-D7DF-21E8-5A8A-46E836172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E74350D1-555C-8175-441F-0EE30CAEDB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BB1701E0-8B3C-5EAF-2C17-731C927AC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454DEC68-F87F-6E9E-FB5D-0AC288C58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B81A3F2F-BC20-081C-272A-4D9AD656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045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9529B0C-D2E2-7AFC-3DD1-A207E3F46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F34F1951-A3AB-D699-6E17-23D4ED947C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C0A5FD74-3B12-AFB9-5989-FB03C1E9F8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C8DB1E0F-9C35-6A39-125B-DDD5E31A4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AC2DB2FB-E247-A216-837C-B1ACD8704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5D6473AF-ACE5-E059-639E-176C84361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915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FA9B820-FD19-9D0D-D3AB-FFFA5851C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9244C6D4-F010-2502-51AB-CB0D82A1DC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CB24A935-5692-248D-27FF-318C09601C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2A10517B-EDAF-41D7-71C0-7E967FA49F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A49D1BFE-5C33-3314-F88E-BB25C12744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B59AE59F-BA5E-FB67-0533-FACAFE015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451863E9-1908-1F0E-9069-0A0E7763C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9E56DB57-2A88-7543-5850-7E480565A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979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B69892D4-EF72-51E5-D755-2270EC32F4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17003291-3389-EF26-54DD-0F579DCBE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D0606A90-0D55-BD30-7F95-AB9F92212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CD38D289-50B9-BEA7-F401-6715E5B6B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52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C0D58550-2916-B27C-C1AE-82246A1B4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3D0D7C87-EB12-161E-1830-9AF4EA370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A92B2E4A-8587-7A96-0EA8-B81FCA750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9199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61A60F31-94C8-1B76-7D60-D5941C1DCE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C0E908FB-545A-B849-CD0F-49ED83BB0E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764EBC00-BA5C-FE9E-2985-CE6673EFEF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E9F8F91C-6CDF-E881-C993-CB8374FD0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ABFD0989-E501-9C8E-07E4-506716957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1522505A-961A-9C46-7F87-D9AF3B4F9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459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3E2A806-E6CB-6C24-2714-C79612073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3391D493-6DFC-AE61-805D-0B7AC137A1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4D16C85A-3EE6-5CD1-5F8C-7EB50FB677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F8615938-4B22-9941-FC35-C828A70A0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64CEE416-4ADE-BC7D-6036-770F71116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6BB335B1-F893-543B-FF35-2A2B4C83F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814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980D1A6E-7787-0C96-F0B5-4126F0720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F8233F37-29DE-58AB-6A2C-5D737537FB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1CB6CEE1-943F-096E-6001-87E62EE34B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F88DAF-6559-4BA0-A77C-ACBF55DA1E63}" type="datetimeFigureOut">
              <a:rPr kumimoji="1" lang="ja-JP" altLang="en-US" smtClean="0"/>
              <a:t>2024/3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D210DAAA-2512-8A7C-BEAC-3898DFBEB2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1BD71218-E5DE-C08E-F2CC-F696BF3087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C5AEC5-A495-423B-98B2-9E282351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876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802CBA2F-A467-7A11-2934-E6C79FC9EF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="" xmlns:a16="http://schemas.microsoft.com/office/drawing/2014/main" id="{BFB891B8-2E56-FB88-BE65-D08484061A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7749" y="1030216"/>
            <a:ext cx="2822225" cy="275910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7D4A4A11-9E33-A54A-BE72-41116473AA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08646" y="3976438"/>
            <a:ext cx="2822225" cy="275910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C89D5CAA-BDEF-726D-B6AF-247CEE15ED7D}"/>
              </a:ext>
            </a:extLst>
          </p:cNvPr>
          <p:cNvSpPr txBox="1"/>
          <p:nvPr/>
        </p:nvSpPr>
        <p:spPr>
          <a:xfrm>
            <a:off x="5800813" y="393312"/>
            <a:ext cx="23291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D8+ TCM </a:t>
            </a:r>
          </a:p>
          <a:p>
            <a:pPr algn="ctr"/>
            <a:r>
              <a:rPr lang="en-US" altLang="ja-JP" sz="1400" dirty="0" smtClean="0"/>
              <a:t>(Upper left</a:t>
            </a:r>
            <a:r>
              <a:rPr lang="en-US" altLang="ja-JP" sz="1400" dirty="0"/>
              <a:t>)</a:t>
            </a:r>
            <a:endParaRPr kumimoji="1" lang="ja-JP" altLang="en-US" sz="1400" dirty="0"/>
          </a:p>
        </p:txBody>
      </p:sp>
      <p:pic>
        <p:nvPicPr>
          <p:cNvPr id="6" name="図 5">
            <a:extLst>
              <a:ext uri="{FF2B5EF4-FFF2-40B4-BE49-F238E27FC236}">
                <a16:creationId xmlns="" xmlns:a16="http://schemas.microsoft.com/office/drawing/2014/main" id="{AEA20F08-F35D-3876-BF6A-47C9DF87E2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35072" y="1010849"/>
            <a:ext cx="2822225" cy="275910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B4FADF84-E28A-38CA-5DA9-50FDC8375C20}"/>
              </a:ext>
            </a:extLst>
          </p:cNvPr>
          <p:cNvSpPr txBox="1"/>
          <p:nvPr/>
        </p:nvSpPr>
        <p:spPr>
          <a:xfrm>
            <a:off x="9028136" y="374458"/>
            <a:ext cx="23291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D8+ </a:t>
            </a:r>
            <a:r>
              <a:rPr lang="en-US" altLang="ja-JP" sz="1400" dirty="0"/>
              <a:t>Teff </a:t>
            </a:r>
          </a:p>
          <a:p>
            <a:pPr algn="ctr"/>
            <a:r>
              <a:rPr kumimoji="1" lang="en-US" altLang="ja-JP" sz="1400" dirty="0" smtClean="0"/>
              <a:t>(Lower right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pic>
        <p:nvPicPr>
          <p:cNvPr id="9" name="図 8">
            <a:extLst>
              <a:ext uri="{FF2B5EF4-FFF2-40B4-BE49-F238E27FC236}">
                <a16:creationId xmlns="" xmlns:a16="http://schemas.microsoft.com/office/drawing/2014/main" id="{36F208B9-7BBA-47D3-CDBE-37A633BD5C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35070" y="3976438"/>
            <a:ext cx="2822225" cy="275910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="" xmlns:a16="http://schemas.microsoft.com/office/drawing/2014/main" id="{EB74EB57-E648-A1A7-19E7-F9A4484F03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89884" y="1017560"/>
            <a:ext cx="2822225" cy="275910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BC3AFA4D-8A96-3679-8745-94CD299656B2}"/>
              </a:ext>
            </a:extLst>
          </p:cNvPr>
          <p:cNvSpPr txBox="1"/>
          <p:nvPr/>
        </p:nvSpPr>
        <p:spPr>
          <a:xfrm>
            <a:off x="2582945" y="374458"/>
            <a:ext cx="23291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D8+ </a:t>
            </a:r>
            <a:r>
              <a:rPr kumimoji="1" lang="en-US" altLang="ja-JP" sz="1400" dirty="0" err="1"/>
              <a:t>Tnaive</a:t>
            </a:r>
            <a:r>
              <a:rPr kumimoji="1" lang="en-US" altLang="ja-JP" sz="1400" dirty="0"/>
              <a:t> </a:t>
            </a:r>
          </a:p>
          <a:p>
            <a:pPr algn="ctr"/>
            <a:r>
              <a:rPr lang="en-US" altLang="ja-JP" sz="1400" dirty="0" smtClean="0"/>
              <a:t>(Upper right</a:t>
            </a:r>
            <a:r>
              <a:rPr lang="en-US" altLang="ja-JP" sz="1400" dirty="0"/>
              <a:t>)</a:t>
            </a:r>
            <a:endParaRPr kumimoji="1" lang="ja-JP" altLang="en-US" sz="1400" dirty="0"/>
          </a:p>
        </p:txBody>
      </p:sp>
      <p:pic>
        <p:nvPicPr>
          <p:cNvPr id="13" name="図 12">
            <a:extLst>
              <a:ext uri="{FF2B5EF4-FFF2-40B4-BE49-F238E27FC236}">
                <a16:creationId xmlns="" xmlns:a16="http://schemas.microsoft.com/office/drawing/2014/main" id="{965DB99E-6230-EC0B-D447-B69360B7BFD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89881" y="3990485"/>
            <a:ext cx="2822225" cy="2759108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1D1DFEF2-3397-A7CF-68E2-B4355505FFCA}"/>
              </a:ext>
            </a:extLst>
          </p:cNvPr>
          <p:cNvSpPr txBox="1"/>
          <p:nvPr/>
        </p:nvSpPr>
        <p:spPr>
          <a:xfrm>
            <a:off x="938978" y="492662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igh</a:t>
            </a:r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AC778C09-FB05-E484-B643-567E048F6754}"/>
              </a:ext>
            </a:extLst>
          </p:cNvPr>
          <p:cNvSpPr txBox="1"/>
          <p:nvPr/>
        </p:nvSpPr>
        <p:spPr>
          <a:xfrm>
            <a:off x="990639" y="1967985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Low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="" xmlns:a16="http://schemas.microsoft.com/office/drawing/2014/main" id="{7C0FE41E-0B5B-FB5F-5646-F7B7874A1BC5}"/>
              </a:ext>
            </a:extLst>
          </p:cNvPr>
          <p:cNvSpPr txBox="1"/>
          <p:nvPr/>
        </p:nvSpPr>
        <p:spPr>
          <a:xfrm>
            <a:off x="0" y="45977"/>
            <a:ext cx="3200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-US" altLang="ja-JP" sz="18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</a:t>
            </a: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1</a:t>
            </a:r>
            <a:endParaRPr lang="en-US" altLang="ja-JP" sz="1800" b="1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00AFF8C0-0900-2CF0-8647-E5A29A2D980D}"/>
              </a:ext>
            </a:extLst>
          </p:cNvPr>
          <p:cNvSpPr txBox="1"/>
          <p:nvPr/>
        </p:nvSpPr>
        <p:spPr>
          <a:xfrm rot="16200000">
            <a:off x="1022454" y="2028495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2B71D991-11EF-A0F0-AC0C-0043F140FC06}"/>
              </a:ext>
            </a:extLst>
          </p:cNvPr>
          <p:cNvSpPr txBox="1"/>
          <p:nvPr/>
        </p:nvSpPr>
        <p:spPr>
          <a:xfrm>
            <a:off x="2600640" y="3582573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1965A8CE-52C3-A98F-2378-A1FDEDE12E77}"/>
              </a:ext>
            </a:extLst>
          </p:cNvPr>
          <p:cNvSpPr txBox="1"/>
          <p:nvPr/>
        </p:nvSpPr>
        <p:spPr>
          <a:xfrm rot="16200000">
            <a:off x="4266847" y="2011209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="" xmlns:a16="http://schemas.microsoft.com/office/drawing/2014/main" id="{FBA68743-B97F-D4A0-F559-8DE10C92387B}"/>
              </a:ext>
            </a:extLst>
          </p:cNvPr>
          <p:cNvSpPr txBox="1"/>
          <p:nvPr/>
        </p:nvSpPr>
        <p:spPr>
          <a:xfrm>
            <a:off x="5807325" y="3565287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7D759CBA-DAA6-5A54-7A03-FC3CF2F71D7E}"/>
              </a:ext>
            </a:extLst>
          </p:cNvPr>
          <p:cNvSpPr txBox="1"/>
          <p:nvPr/>
        </p:nvSpPr>
        <p:spPr>
          <a:xfrm rot="16200000">
            <a:off x="7492388" y="1993923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B3478893-3CC9-AF74-2E49-78CBEA765983}"/>
              </a:ext>
            </a:extLst>
          </p:cNvPr>
          <p:cNvSpPr txBox="1"/>
          <p:nvPr/>
        </p:nvSpPr>
        <p:spPr>
          <a:xfrm>
            <a:off x="9032866" y="3548001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="" xmlns:a16="http://schemas.microsoft.com/office/drawing/2014/main" id="{2D43E630-74D8-9954-55DD-25751C0849B9}"/>
              </a:ext>
            </a:extLst>
          </p:cNvPr>
          <p:cNvSpPr txBox="1"/>
          <p:nvPr/>
        </p:nvSpPr>
        <p:spPr>
          <a:xfrm rot="16200000">
            <a:off x="997319" y="4972804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="" xmlns:a16="http://schemas.microsoft.com/office/drawing/2014/main" id="{5F8F0C58-0E23-7453-C34A-94756FF4A8C8}"/>
              </a:ext>
            </a:extLst>
          </p:cNvPr>
          <p:cNvSpPr txBox="1"/>
          <p:nvPr/>
        </p:nvSpPr>
        <p:spPr>
          <a:xfrm>
            <a:off x="2537797" y="6526882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7A5D0DE1-3DBE-14D6-DD81-84AD43576954}"/>
              </a:ext>
            </a:extLst>
          </p:cNvPr>
          <p:cNvSpPr txBox="1"/>
          <p:nvPr/>
        </p:nvSpPr>
        <p:spPr>
          <a:xfrm rot="16200000">
            <a:off x="4240136" y="4972796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ADFF6A04-F7A5-1A8B-13B0-3826DCA75AD3}"/>
              </a:ext>
            </a:extLst>
          </p:cNvPr>
          <p:cNvSpPr txBox="1"/>
          <p:nvPr/>
        </p:nvSpPr>
        <p:spPr>
          <a:xfrm>
            <a:off x="5780614" y="6526874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79150125-4D8E-6FB5-DB7A-2F229030D121}"/>
              </a:ext>
            </a:extLst>
          </p:cNvPr>
          <p:cNvSpPr txBox="1"/>
          <p:nvPr/>
        </p:nvSpPr>
        <p:spPr>
          <a:xfrm rot="16200000">
            <a:off x="7464108" y="4953944"/>
            <a:ext cx="22746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CCR7</a:t>
            </a:r>
            <a:endParaRPr kumimoji="1" lang="ja-JP" altLang="en-US" sz="12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D143AC9F-BD7C-9366-CF1C-8985C9568BD0}"/>
              </a:ext>
            </a:extLst>
          </p:cNvPr>
          <p:cNvSpPr txBox="1"/>
          <p:nvPr/>
        </p:nvSpPr>
        <p:spPr>
          <a:xfrm>
            <a:off x="9004586" y="6508022"/>
            <a:ext cx="23114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CD45RA</a:t>
            </a:r>
            <a:endParaRPr kumimoji="1" lang="ja-JP" altLang="en-US" sz="1200" dirty="0"/>
          </a:p>
        </p:txBody>
      </p:sp>
      <p:cxnSp>
        <p:nvCxnSpPr>
          <p:cNvPr id="28" name="直線コネクタ 27">
            <a:extLst>
              <a:ext uri="{FF2B5EF4-FFF2-40B4-BE49-F238E27FC236}">
                <a16:creationId xmlns="" xmlns:a16="http://schemas.microsoft.com/office/drawing/2014/main" id="{9D66F11E-F2EC-F7EF-711C-9EADDBA7BF0D}"/>
              </a:ext>
            </a:extLst>
          </p:cNvPr>
          <p:cNvCxnSpPr>
            <a:cxnSpLocks/>
          </p:cNvCxnSpPr>
          <p:nvPr/>
        </p:nvCxnSpPr>
        <p:spPr>
          <a:xfrm>
            <a:off x="688157" y="3885418"/>
            <a:ext cx="111833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="" xmlns:a16="http://schemas.microsoft.com/office/drawing/2014/main" id="{063C1BA8-B34B-1420-6DA4-92035DC57957}"/>
              </a:ext>
            </a:extLst>
          </p:cNvPr>
          <p:cNvCxnSpPr>
            <a:cxnSpLocks/>
          </p:cNvCxnSpPr>
          <p:nvPr/>
        </p:nvCxnSpPr>
        <p:spPr>
          <a:xfrm>
            <a:off x="678730" y="926774"/>
            <a:ext cx="111833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="" xmlns:a16="http://schemas.microsoft.com/office/drawing/2014/main" id="{DAF04EBA-02CD-0501-0A9C-A019AC9C0086}"/>
              </a:ext>
            </a:extLst>
          </p:cNvPr>
          <p:cNvCxnSpPr>
            <a:cxnSpLocks/>
          </p:cNvCxnSpPr>
          <p:nvPr/>
        </p:nvCxnSpPr>
        <p:spPr>
          <a:xfrm>
            <a:off x="1902829" y="435650"/>
            <a:ext cx="0" cy="6200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="" xmlns:a16="http://schemas.microsoft.com/office/drawing/2014/main" id="{38D70C4B-C492-E902-1F78-DBE73EE968DD}"/>
              </a:ext>
            </a:extLst>
          </p:cNvPr>
          <p:cNvCxnSpPr>
            <a:cxnSpLocks/>
          </p:cNvCxnSpPr>
          <p:nvPr/>
        </p:nvCxnSpPr>
        <p:spPr>
          <a:xfrm>
            <a:off x="5167644" y="396455"/>
            <a:ext cx="0" cy="62321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="" xmlns:a16="http://schemas.microsoft.com/office/drawing/2014/main" id="{69E83F36-D8FB-6E1D-DD02-C0612D111216}"/>
              </a:ext>
            </a:extLst>
          </p:cNvPr>
          <p:cNvCxnSpPr>
            <a:cxnSpLocks/>
          </p:cNvCxnSpPr>
          <p:nvPr/>
        </p:nvCxnSpPr>
        <p:spPr>
          <a:xfrm>
            <a:off x="8355477" y="416877"/>
            <a:ext cx="0" cy="62321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55683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=""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=""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0</TotalTime>
  <Words>62</Words>
  <Application>Microsoft Office PowerPoint</Application>
  <PresentationFormat>Custom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Greg Adams</cp:lastModifiedBy>
  <cp:revision>6</cp:revision>
  <dcterms:created xsi:type="dcterms:W3CDTF">2024-03-06T12:43:33Z</dcterms:created>
  <dcterms:modified xsi:type="dcterms:W3CDTF">2024-03-13T05:09:37Z</dcterms:modified>
</cp:coreProperties>
</file>